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 showGuides="1">
      <p:cViewPr varScale="1">
        <p:scale>
          <a:sx n="111" d="100"/>
          <a:sy n="111" d="100"/>
        </p:scale>
        <p:origin x="1458" y="11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E6CA39-B214-4930-B05B-358AD5AEE95D}" type="datetimeFigureOut">
              <a:rPr kumimoji="1" lang="ja-JP" altLang="en-US" smtClean="0"/>
              <a:t>2021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BF87A5-097B-40DA-BC4C-BCE872905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99265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E6CA39-B214-4930-B05B-358AD5AEE95D}" type="datetimeFigureOut">
              <a:rPr kumimoji="1" lang="ja-JP" altLang="en-US" smtClean="0"/>
              <a:t>2021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BF87A5-097B-40DA-BC4C-BCE872905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24923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E6CA39-B214-4930-B05B-358AD5AEE95D}" type="datetimeFigureOut">
              <a:rPr kumimoji="1" lang="ja-JP" altLang="en-US" smtClean="0"/>
              <a:t>2021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BF87A5-097B-40DA-BC4C-BCE872905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36271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E6CA39-B214-4930-B05B-358AD5AEE95D}" type="datetimeFigureOut">
              <a:rPr kumimoji="1" lang="ja-JP" altLang="en-US" smtClean="0"/>
              <a:t>2021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BF87A5-097B-40DA-BC4C-BCE872905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38228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E6CA39-B214-4930-B05B-358AD5AEE95D}" type="datetimeFigureOut">
              <a:rPr kumimoji="1" lang="ja-JP" altLang="en-US" smtClean="0"/>
              <a:t>2021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BF87A5-097B-40DA-BC4C-BCE872905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04395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E6CA39-B214-4930-B05B-358AD5AEE95D}" type="datetimeFigureOut">
              <a:rPr kumimoji="1" lang="ja-JP" altLang="en-US" smtClean="0"/>
              <a:t>2021/1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BF87A5-097B-40DA-BC4C-BCE872905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38127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E6CA39-B214-4930-B05B-358AD5AEE95D}" type="datetimeFigureOut">
              <a:rPr kumimoji="1" lang="ja-JP" altLang="en-US" smtClean="0"/>
              <a:t>2021/1/1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BF87A5-097B-40DA-BC4C-BCE872905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41042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E6CA39-B214-4930-B05B-358AD5AEE95D}" type="datetimeFigureOut">
              <a:rPr kumimoji="1" lang="ja-JP" altLang="en-US" smtClean="0"/>
              <a:t>2021/1/1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BF87A5-097B-40DA-BC4C-BCE872905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0718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E6CA39-B214-4930-B05B-358AD5AEE95D}" type="datetimeFigureOut">
              <a:rPr kumimoji="1" lang="ja-JP" altLang="en-US" smtClean="0"/>
              <a:t>2021/1/1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BF87A5-097B-40DA-BC4C-BCE872905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69729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E6CA39-B214-4930-B05B-358AD5AEE95D}" type="datetimeFigureOut">
              <a:rPr kumimoji="1" lang="ja-JP" altLang="en-US" smtClean="0"/>
              <a:t>2021/1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BF87A5-097B-40DA-BC4C-BCE872905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14472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E6CA39-B214-4930-B05B-358AD5AEE95D}" type="datetimeFigureOut">
              <a:rPr kumimoji="1" lang="ja-JP" altLang="en-US" smtClean="0"/>
              <a:t>2021/1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BF87A5-097B-40DA-BC4C-BCE872905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60121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E6CA39-B214-4930-B05B-358AD5AEE95D}" type="datetimeFigureOut">
              <a:rPr kumimoji="1" lang="ja-JP" altLang="en-US" smtClean="0"/>
              <a:t>2021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BF87A5-097B-40DA-BC4C-BCE872905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55991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id="{69E8C6C4-4AC4-454E-B0CA-09920C2639E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8774" y="609140"/>
            <a:ext cx="7986452" cy="4511430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41153175-7CB5-48D9-B6DD-579BD6BDF2D3}"/>
              </a:ext>
            </a:extLst>
          </p:cNvPr>
          <p:cNvSpPr txBox="1"/>
          <p:nvPr/>
        </p:nvSpPr>
        <p:spPr>
          <a:xfrm>
            <a:off x="1080654" y="5162135"/>
            <a:ext cx="7282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. of patients		71            21               9               6               6                5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95C6030-A98A-4AA0-8975-D2F574416D5F}"/>
              </a:ext>
            </a:extLst>
          </p:cNvPr>
          <p:cNvSpPr txBox="1"/>
          <p:nvPr/>
        </p:nvSpPr>
        <p:spPr>
          <a:xfrm rot="16200000">
            <a:off x="1149927" y="2521527"/>
            <a:ext cx="21980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portion of patients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663D2A7C-CA9A-4907-9CDD-0359DEA8F7C8}"/>
              </a:ext>
            </a:extLst>
          </p:cNvPr>
          <p:cNvSpPr txBox="1"/>
          <p:nvPr/>
        </p:nvSpPr>
        <p:spPr>
          <a:xfrm>
            <a:off x="4862945" y="4751238"/>
            <a:ext cx="24399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to CRPC (months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0CBB7555-0F19-49C8-B0F9-FDB986AE2BA6}"/>
              </a:ext>
            </a:extLst>
          </p:cNvPr>
          <p:cNvSpPr txBox="1"/>
          <p:nvPr/>
        </p:nvSpPr>
        <p:spPr>
          <a:xfrm>
            <a:off x="457200" y="290945"/>
            <a:ext cx="18473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F193D34F-4B5D-4AA5-AFF4-0E6B291A85B7}"/>
              </a:ext>
            </a:extLst>
          </p:cNvPr>
          <p:cNvSpPr txBox="1"/>
          <p:nvPr/>
        </p:nvSpPr>
        <p:spPr>
          <a:xfrm>
            <a:off x="5070763" y="5879528"/>
            <a:ext cx="33329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dian time to CRPC: 15 months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0997E6C2-294F-428A-9DF1-78B05F2B1204}"/>
              </a:ext>
            </a:extLst>
          </p:cNvPr>
          <p:cNvSpPr txBox="1"/>
          <p:nvPr/>
        </p:nvSpPr>
        <p:spPr>
          <a:xfrm>
            <a:off x="641931" y="209030"/>
            <a:ext cx="124123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>
                <a:latin typeface="Times New Roman" pitchFamily="18" charset="0"/>
                <a:cs typeface="Times New Roman" pitchFamily="18" charset="0"/>
              </a:rPr>
              <a:t>Figure S1</a:t>
            </a:r>
            <a:endParaRPr kumimoji="1" lang="ja-JP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823676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</TotalTime>
  <Words>30</Words>
  <Application>Microsoft Office PowerPoint</Application>
  <PresentationFormat>画面に合わせる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akanishi shotaro</dc:creator>
  <cp:lastModifiedBy>仲西　昌太郎</cp:lastModifiedBy>
  <cp:revision>12</cp:revision>
  <dcterms:created xsi:type="dcterms:W3CDTF">2020-04-18T03:40:34Z</dcterms:created>
  <dcterms:modified xsi:type="dcterms:W3CDTF">2021-01-12T11:18:12Z</dcterms:modified>
</cp:coreProperties>
</file>